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789DE69-2118-4A49-9A4E-9B37E47209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414D98F2-D97D-453F-BCDA-9E7EB33CD1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13B85AE-6BBF-4AD1-A638-9F700F714A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696BA1D-F9B7-428D-ADBE-7082274AD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01419BC-B5C7-4B62-BB14-30A1EB6F2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5993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EB25C04-CC76-411B-8364-992880B3ED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407BF196-474B-48B4-8162-54E29B360F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2BC20AE-558B-402D-BBA4-32CCCF08B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D709884-36A3-46C5-BEAD-031E9780F7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5FBD791-BEEA-42BB-9F25-9E45DE2E08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375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DDC541F-8C7E-4F2A-8258-B64FB0FA6D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E898A52-5497-41C7-AC81-304222AF4A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4AADB53-E566-49AC-9664-95E58C9903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A9DECE7-F53C-42FF-9C66-8D94FB503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C53E8C7-8FF0-499C-ACE5-AA1880E88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3839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549CDBA-BECB-402E-805D-105E928584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92A6116B-BCD3-4CA3-B511-8DEE911580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D525FB8-E86F-4B83-BC78-4B5A48A47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AB9417E-6044-4467-917E-80606FFB4F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711E6FA-F7C9-474D-BEFC-1662E635A4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128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DC85487-8231-403C-8FB0-94F8C6C341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8E295B3-A9DE-45DB-A4A1-12F3C0C05B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A116442-C5AC-47A9-B431-96C6DF57AD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32B4AEE-E71D-4F59-8313-DC7859DDEE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86A21D0-E12B-4F9F-ADE0-5AB4323268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4526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E9BF021-C931-42C7-999A-83677F173B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603969-1FA1-4AF5-B96B-B25231D2AF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6097247-DD3D-4EE2-8E13-AD92333552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6EF07CBF-7C3B-429B-AF70-A05771DDA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D8DD9C65-FF6A-4139-9A82-6C6276338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36DC7BB-866C-488C-BAFD-857BDC1FF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4603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D5DD7D4-52CF-4325-BFE7-8022A35EB9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1149D26-F36B-42D6-9B1A-6776438912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6F115A0-5771-4B44-8FB3-A611307D5A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09203C37-8155-4A15-8D7E-B3F0B5A063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81D3F65C-63A5-40B1-8835-5DA2691C28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C1D459B1-2641-41F6-B20A-27835101C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4E7B413-838E-4AB7-9FEE-398C1399CF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A7BB6D0C-7695-4CD7-8734-37E790E8A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116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21A8CA-5CAC-470D-8FBC-5BDA5ED0DE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CDE3E91-E451-4E79-989C-137F27FEE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372EE7FE-41EB-4AA0-93BA-50F4B0685D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50CA4B3-8BFD-446C-900B-19D894CFD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152098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B628A77D-94EB-4150-A4C5-C5B6EE059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16342F3-4993-4A48-8C17-A44F64CBD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65CF6835-03EA-49AA-965D-4A18E0103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4884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94590F-C1AF-4AA0-ABFE-5EC0F85DE9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B82A2EF-7C90-49A8-8E9A-AA32CD523A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A319C8A-3BBB-4059-BEFB-039C695C2E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B4624DD-27A8-4B7D-8070-F453F79A1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3C8410E-AC09-495B-A830-7DA32C568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8414FF50-2CD5-41C1-B51A-3C44AD009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19681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E988C1B-71E4-4F98-BB7B-C47149E20F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CFF4A1A-1A00-4594-9A80-8A52D71508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D0D8032-8734-459E-B7B7-EDA2ADF8AE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57A2298-F355-402F-A76C-CB827EDA8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EDCF944-FE75-4D79-9067-3473A536D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B01EFAD-F98F-4D93-943F-9588E23A3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3466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244A40B9-E39F-4A61-A058-54661F665D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4956219-D3E9-48FB-9919-A447EAA9A6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D200243-7B90-4027-AEC3-ED1E0482D49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73F3D0-C441-4E9F-97FC-E1C9E7DB5069}" type="datetimeFigureOut">
              <a:rPr lang="fr-FR" smtClean="0"/>
              <a:t>14/11/2024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4CBB4BD-40C2-49C5-91BB-8ED67EA13F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039B8AA-4A2F-45C6-A4E8-CB363A5519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546EA-0239-4A95-A949-A4290C0C438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034782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D828D2E3-E611-4926-80D7-B0F3DBF68E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0000" y="71351"/>
            <a:ext cx="5676900" cy="6477000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3BB28BD4-AE6E-4600-AC2A-35AAF750D0F3}"/>
              </a:ext>
            </a:extLst>
          </p:cNvPr>
          <p:cNvSpPr txBox="1"/>
          <p:nvPr/>
        </p:nvSpPr>
        <p:spPr>
          <a:xfrm>
            <a:off x="7238448" y="344208"/>
            <a:ext cx="4707544" cy="1754326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just"/>
            <a:r>
              <a:rPr lang="fr-FR" dirty="0"/>
              <a:t>In all the cases, </a:t>
            </a:r>
            <a:r>
              <a:rPr lang="fr-FR" dirty="0" err="1"/>
              <a:t>we</a:t>
            </a:r>
            <a:r>
              <a:rPr lang="fr-FR" dirty="0"/>
              <a:t> </a:t>
            </a:r>
            <a:r>
              <a:rPr lang="fr-FR" dirty="0" err="1"/>
              <a:t>see</a:t>
            </a:r>
            <a:r>
              <a:rPr lang="fr-FR" dirty="0"/>
              <a:t> </a:t>
            </a:r>
            <a:r>
              <a:rPr lang="fr-FR" dirty="0" err="1"/>
              <a:t>that</a:t>
            </a:r>
            <a:r>
              <a:rPr lang="fr-FR" dirty="0"/>
              <a:t> for a </a:t>
            </a:r>
            <a:r>
              <a:rPr lang="fr-FR" dirty="0" err="1"/>
              <a:t>same</a:t>
            </a:r>
            <a:r>
              <a:rPr lang="fr-FR" dirty="0"/>
              <a:t> </a:t>
            </a:r>
            <a:r>
              <a:rPr lang="fr-FR" dirty="0" err="1"/>
              <a:t>Location_Sample_Date</a:t>
            </a:r>
            <a:r>
              <a:rPr lang="fr-FR" dirty="0"/>
              <a:t>, the barycentres of </a:t>
            </a:r>
            <a:r>
              <a:rPr lang="fr-FR" dirty="0" err="1"/>
              <a:t>both</a:t>
            </a:r>
            <a:r>
              <a:rPr lang="fr-FR" dirty="0"/>
              <a:t> sexes have close </a:t>
            </a:r>
            <a:r>
              <a:rPr lang="fr-FR" dirty="0" err="1"/>
              <a:t>coordinates</a:t>
            </a:r>
            <a:r>
              <a:rPr lang="fr-FR" dirty="0"/>
              <a:t> on the first </a:t>
            </a:r>
            <a:r>
              <a:rPr lang="fr-FR" dirty="0" err="1"/>
              <a:t>two</a:t>
            </a:r>
            <a:r>
              <a:rPr lang="fr-FR" dirty="0"/>
              <a:t> dimensions (</a:t>
            </a:r>
            <a:r>
              <a:rPr lang="fr-FR" dirty="0" err="1"/>
              <a:t>see</a:t>
            </a:r>
            <a:r>
              <a:rPr lang="fr-FR" dirty="0"/>
              <a:t> Figure) and more </a:t>
            </a:r>
            <a:r>
              <a:rPr lang="fr-FR" dirty="0" err="1"/>
              <a:t>generally</a:t>
            </a:r>
            <a:r>
              <a:rPr lang="fr-FR" dirty="0"/>
              <a:t> on the first five dimensions (</a:t>
            </a:r>
            <a:r>
              <a:rPr lang="fr-FR" dirty="0" err="1"/>
              <a:t>see</a:t>
            </a:r>
            <a:r>
              <a:rPr lang="fr-FR" dirty="0"/>
              <a:t> </a:t>
            </a:r>
            <a:r>
              <a:rPr lang="fr-FR" dirty="0" err="1"/>
              <a:t>Supplementary</a:t>
            </a:r>
            <a:r>
              <a:rPr lang="fr-FR" dirty="0"/>
              <a:t> Table "</a:t>
            </a:r>
            <a:r>
              <a:rPr lang="fr-FR" dirty="0" err="1"/>
              <a:t>PCA_Barycentres_Coordinates</a:t>
            </a:r>
            <a:r>
              <a:rPr lang="fr-FR" dirty="0"/>
              <a:t>").</a:t>
            </a:r>
          </a:p>
        </p:txBody>
      </p:sp>
    </p:spTree>
    <p:extLst>
      <p:ext uri="{BB962C8B-B14F-4D97-AF65-F5344CB8AC3E}">
        <p14:creationId xmlns:p14="http://schemas.microsoft.com/office/powerpoint/2010/main" val="19982315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7</TotalTime>
  <Words>53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arles Rodde</dc:creator>
  <cp:lastModifiedBy>Charles Rodde</cp:lastModifiedBy>
  <cp:revision>13</cp:revision>
  <dcterms:created xsi:type="dcterms:W3CDTF">2024-03-24T02:27:38Z</dcterms:created>
  <dcterms:modified xsi:type="dcterms:W3CDTF">2024-11-14T07:13:34Z</dcterms:modified>
</cp:coreProperties>
</file>